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B435A-512B-4826-9A66-45D9F179EF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EB34B9-5E88-4601-9709-C8FEC6C1E9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D0994-245B-4A87-A479-8DA75E070B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73346-7F5F-49DF-860A-560E324D0A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2C5EC-7DFA-4893-9B02-CF239A6718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E4833-59A4-4481-BF18-BA4B600C84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12830-2F73-4D19-B775-BBEF006524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8058E-1D09-4501-9979-0D4857E72A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D2E9A-5A40-43C3-9297-E9D1752CA5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3A78B-FA3E-4F6D-A4E6-33196266AB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637D4-6438-49D9-8F2E-F9DC2046E9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C067D-2730-49E7-9051-19862F0FE2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06A817-6B44-41DC-9A0D-A6BDB9E2793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28600" y="654120"/>
            <a:ext cx="2777040" cy="1609560"/>
            <a:chOff x="228600" y="654120"/>
            <a:chExt cx="2777040" cy="1609560"/>
          </a:xfrm>
        </p:grpSpPr>
        <p:sp>
          <p:nvSpPr>
            <p:cNvPr id="42" name=""/>
            <p:cNvSpPr/>
            <p:nvPr/>
          </p:nvSpPr>
          <p:spPr>
            <a:xfrm>
              <a:off x="635040" y="1571760"/>
              <a:ext cx="136440" cy="5061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977760" y="1873080"/>
              <a:ext cx="141480" cy="2048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325520" y="1639800"/>
              <a:ext cx="136440" cy="4381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666800" y="1144440"/>
              <a:ext cx="138240" cy="9334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009880" y="1685880"/>
              <a:ext cx="136440" cy="3920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351160" y="1531800"/>
              <a:ext cx="142920" cy="5461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700360" y="1639800"/>
              <a:ext cx="136440" cy="4381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31720" y="1058760"/>
              <a:ext cx="0" cy="1019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09760" y="20779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09760" y="19303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09760" y="178740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09760" y="163980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09760" y="149688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09760" y="134928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09760" y="12063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09760" y="10587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31720" y="2077920"/>
              <a:ext cx="2408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flipV="1">
              <a:off x="53172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87480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V="1">
              <a:off x="122220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156528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V="1">
              <a:off x="190656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224964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V="1">
              <a:off x="259704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294012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259280" y="654120"/>
              <a:ext cx="7689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300" spc="-1" strike="noStrike">
                  <a:solidFill>
                    <a:srgbClr val="000000"/>
                  </a:solidFill>
                  <a:latin typeface="Arial"/>
                </a:rPr>
                <a:t>MT1-MMP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30200" y="2033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84480" y="18842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84480" y="17413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84480" y="15937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84480" y="14508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84480" y="1303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84480" y="11606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84480" y="10126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34240" y="2141640"/>
              <a:ext cx="36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UMUC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947880" y="2141640"/>
              <a:ext cx="22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53J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226160" y="2141640"/>
              <a:ext cx="36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HT13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631520" y="2141640"/>
              <a:ext cx="23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EJ2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992240" y="2141640"/>
              <a:ext cx="176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T2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284920" y="2141640"/>
              <a:ext cx="30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RT1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643840" y="2141640"/>
              <a:ext cx="36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HT11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6200000">
              <a:off x="-130320" y="1519560"/>
              <a:ext cx="825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Relative expressio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"/>
          <p:cNvGrpSpPr/>
          <p:nvPr/>
        </p:nvGrpSpPr>
        <p:grpSpPr>
          <a:xfrm>
            <a:off x="3543480" y="653760"/>
            <a:ext cx="2775240" cy="1609560"/>
            <a:chOff x="3543480" y="653760"/>
            <a:chExt cx="2775240" cy="1609560"/>
          </a:xfrm>
        </p:grpSpPr>
        <p:sp>
          <p:nvSpPr>
            <p:cNvPr id="85" name=""/>
            <p:cNvSpPr/>
            <p:nvPr/>
          </p:nvSpPr>
          <p:spPr>
            <a:xfrm>
              <a:off x="3948120" y="1195200"/>
              <a:ext cx="136440" cy="8827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290840" y="2066760"/>
              <a:ext cx="141480" cy="111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638600" y="1758600"/>
              <a:ext cx="136440" cy="3193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979880" y="2055600"/>
              <a:ext cx="138240" cy="223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664240" y="2060280"/>
              <a:ext cx="142920" cy="176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6013440" y="1811160"/>
              <a:ext cx="136440" cy="2667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844800" y="1058760"/>
              <a:ext cx="0" cy="1019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822840" y="207792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822840" y="19634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822840" y="18507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822840" y="17366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822840" y="16221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822840" y="15141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822840" y="14000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822840" y="12855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822840" y="117144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822840" y="1058760"/>
              <a:ext cx="219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844800" y="2077920"/>
              <a:ext cx="2408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384480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flipV="1">
              <a:off x="418788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453564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487836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V="1">
              <a:off x="521964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flipV="1">
              <a:off x="556272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591012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6253200" y="207792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615920" y="653760"/>
              <a:ext cx="5310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300" spc="-1" strike="noStrike">
                  <a:solidFill>
                    <a:srgbClr val="000000"/>
                  </a:solidFill>
                  <a:latin typeface="Arial"/>
                </a:rPr>
                <a:t>MMP-2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743280" y="20332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697560" y="19191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697560" y="18046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697560" y="16905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697560" y="15760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697560" y="14680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697560" y="13539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697560" y="12412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697560" y="11268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697560" y="10126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842640" y="2141280"/>
              <a:ext cx="36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UMUC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260960" y="2141280"/>
              <a:ext cx="22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53J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544280" y="2141280"/>
              <a:ext cx="36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HT13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954320" y="2141280"/>
              <a:ext cx="23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EJ2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5310360" y="2141280"/>
              <a:ext cx="176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T2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5588280" y="2141280"/>
              <a:ext cx="30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RT1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956920" y="2141280"/>
              <a:ext cx="36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HT11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rot="16200000">
              <a:off x="3184200" y="1515960"/>
              <a:ext cx="825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Relative expressio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0" name=""/>
          <p:cNvGrpSpPr/>
          <p:nvPr/>
        </p:nvGrpSpPr>
        <p:grpSpPr>
          <a:xfrm>
            <a:off x="1639800" y="2957400"/>
            <a:ext cx="2953440" cy="1706400"/>
            <a:chOff x="1639800" y="2957400"/>
            <a:chExt cx="2953440" cy="1706400"/>
          </a:xfrm>
        </p:grpSpPr>
        <p:sp>
          <p:nvSpPr>
            <p:cNvPr id="131" name=""/>
            <p:cNvSpPr/>
            <p:nvPr/>
          </p:nvSpPr>
          <p:spPr>
            <a:xfrm>
              <a:off x="2030400" y="4273560"/>
              <a:ext cx="146160" cy="2048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403360" y="4051440"/>
              <a:ext cx="154080" cy="4269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784600" y="3419640"/>
              <a:ext cx="145800" cy="10587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157560" y="4227480"/>
              <a:ext cx="154080" cy="2509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3538440" y="4187880"/>
              <a:ext cx="146160" cy="2905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3911760" y="4410000"/>
              <a:ext cx="152280" cy="6840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290840" y="3624120"/>
              <a:ext cx="147960" cy="8542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920960" y="3362400"/>
              <a:ext cx="0" cy="1116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895400" y="447840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895400" y="431964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895400" y="415908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895400" y="400068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895400" y="384012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895400" y="368136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895400" y="352116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895400" y="336240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920960" y="4478400"/>
              <a:ext cx="2635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1920960" y="447840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2295360" y="447840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2673360" y="447840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flipV="1">
              <a:off x="3048120" y="447840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3427560" y="447840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3801960" y="447840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4179960" y="447840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4556160" y="4478400"/>
              <a:ext cx="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2791800" y="2957400"/>
              <a:ext cx="5403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300" spc="-1" strike="noStrike">
                  <a:solidFill>
                    <a:srgbClr val="000000"/>
                  </a:solidFill>
                  <a:latin typeface="Arial"/>
                </a:rPr>
                <a:t>TIMP-2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811160" y="44337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811160" y="4273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811160" y="41148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1811160" y="39546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811160" y="3795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1811160" y="36352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811160" y="34750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1811160" y="3316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1916280" y="4541760"/>
              <a:ext cx="433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UMUC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2349360" y="4541760"/>
              <a:ext cx="25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253J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2701080" y="4541760"/>
              <a:ext cx="36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HT13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3152520" y="4541760"/>
              <a:ext cx="23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EJ2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3549600" y="4541760"/>
              <a:ext cx="176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T2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3851640" y="4541760"/>
              <a:ext cx="30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RT1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4231440" y="4541760"/>
              <a:ext cx="36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HT11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rot="16200000">
              <a:off x="1280520" y="3875400"/>
              <a:ext cx="825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Relative expressio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3" name=""/>
          <p:cNvSpPr/>
          <p:nvPr/>
        </p:nvSpPr>
        <p:spPr>
          <a:xfrm>
            <a:off x="866880" y="5024520"/>
            <a:ext cx="524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Relative expression of MT1-MMP, MMP2 and TIMP-2 mRNA in a panel of UCC cell li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8-26T12:04:49Z</dcterms:created>
  <dc:creator>Matthew Wallard</dc:creator>
  <dc:description/>
  <dc:language>en-US</dc:language>
  <cp:lastModifiedBy>Administrator</cp:lastModifiedBy>
  <dcterms:modified xsi:type="dcterms:W3CDTF">2008-06-11T15:34:20Z</dcterms:modified>
  <cp:revision>6</cp:revision>
  <dc:subject/>
  <dc:title>Slide 1</dc:title>
</cp:coreProperties>
</file>